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58400" cy="7772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69051B-30BB-4DCA-AB4C-328EE3C132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6A899-AFD3-4DC0-B13F-E5EF8AB2EB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1DA54-71CE-4157-9F13-FC3FCC8885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17FF9-80FC-43DE-88B5-A0E8DF9484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8D152-D55F-4B7B-99AB-6EFFFF3D08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BC00F-9499-4ED0-8B0A-035005B817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796A7-9B5B-4C1A-9170-A3B6992669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B163C3-A715-49B8-A9E0-0DD51EE97E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DDA5F-AB9F-4E12-88CA-8A6A41109F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38A8D-8D77-4CF6-BEBA-BE520209CB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2F3CF-B4A2-45E3-B2E5-F5B479C949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F4EFE-6BF6-4406-9D9B-13CAD6F96E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4B46B4-9B41-4FB9-A338-815E29EA194A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55680" y="242640"/>
            <a:ext cx="9360000" cy="59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55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igure S4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mino acid sequence alignment of melon CmCAD1 (MELO3C019548P1a) and CmCAD2 (MELO3C018492P1a) with closely related sequences of other plants.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569360" y="7188120"/>
            <a:ext cx="2425680" cy="52092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2209680" y="746280"/>
            <a:ext cx="6019920" cy="1468440"/>
            <a:chOff x="2209680" y="746280"/>
            <a:chExt cx="6019920" cy="1468440"/>
          </a:xfrm>
        </p:grpSpPr>
        <p:sp>
          <p:nvSpPr>
            <p:cNvPr id="44" name=""/>
            <p:cNvSpPr/>
            <p:nvPr/>
          </p:nvSpPr>
          <p:spPr>
            <a:xfrm>
              <a:off x="5841360" y="17787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957280" y="17787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276680" y="17787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085160" y="1986480"/>
              <a:ext cx="11444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2"/>
            <a:stretch/>
          </p:blipFill>
          <p:spPr>
            <a:xfrm>
              <a:off x="2209680" y="881280"/>
              <a:ext cx="6017400" cy="1086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5821200" y="759240"/>
              <a:ext cx="230040" cy="45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5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256520" y="759240"/>
              <a:ext cx="228240" cy="45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5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841360" y="7462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957280" y="80172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994720" y="932040"/>
              <a:ext cx="24732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185880" y="80172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312320" y="917280"/>
              <a:ext cx="573120" cy="103248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893560" y="1917000"/>
              <a:ext cx="17244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6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009480" y="1917000"/>
              <a:ext cx="17244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6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7328880" y="1899360"/>
              <a:ext cx="17244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6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2209680" y="2209680"/>
            <a:ext cx="6019920" cy="1347480"/>
            <a:chOff x="2209680" y="2209680"/>
            <a:chExt cx="6019920" cy="1347480"/>
          </a:xfrm>
        </p:grpSpPr>
        <p:sp>
          <p:nvSpPr>
            <p:cNvPr id="60" name=""/>
            <p:cNvSpPr/>
            <p:nvPr/>
          </p:nvSpPr>
          <p:spPr>
            <a:xfrm>
              <a:off x="2439720" y="3328920"/>
              <a:ext cx="11494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1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985920" y="3328920"/>
              <a:ext cx="11476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Zn2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" descr=""/>
            <p:cNvPicPr/>
            <p:nvPr/>
          </p:nvPicPr>
          <p:blipFill>
            <a:blip r:embed="rId3"/>
            <a:stretch/>
          </p:blipFill>
          <p:spPr>
            <a:xfrm>
              <a:off x="2209680" y="2209680"/>
              <a:ext cx="6019920" cy="1100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"/>
            <p:cNvSpPr/>
            <p:nvPr/>
          </p:nvSpPr>
          <p:spPr>
            <a:xfrm>
              <a:off x="2725560" y="2264760"/>
              <a:ext cx="342720" cy="104544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333680" y="2244600"/>
              <a:ext cx="22716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560840" y="2244600"/>
              <a:ext cx="23004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643560" y="2246040"/>
              <a:ext cx="1777680" cy="106416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733640" y="2244600"/>
              <a:ext cx="23004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249880" y="2244600"/>
              <a:ext cx="22500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59040" rIns="59040" tIns="29520" bIns="2952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▼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"/>
          <p:cNvGrpSpPr/>
          <p:nvPr/>
        </p:nvGrpSpPr>
        <p:grpSpPr>
          <a:xfrm>
            <a:off x="2133720" y="3505320"/>
            <a:ext cx="6095880" cy="1361880"/>
            <a:chOff x="2133720" y="3505320"/>
            <a:chExt cx="6095880" cy="1361880"/>
          </a:xfrm>
        </p:grpSpPr>
        <p:sp>
          <p:nvSpPr>
            <p:cNvPr id="70" name=""/>
            <p:cNvSpPr/>
            <p:nvPr/>
          </p:nvSpPr>
          <p:spPr>
            <a:xfrm>
              <a:off x="3429720" y="354312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490200" y="454824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4806000" y="4797360"/>
              <a:ext cx="1443240" cy="69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2040" bIns="3204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NADPH binding moti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" descr=""/>
            <p:cNvPicPr/>
            <p:nvPr/>
          </p:nvPicPr>
          <p:blipFill>
            <a:blip r:embed="rId4"/>
            <a:stretch/>
          </p:blipFill>
          <p:spPr>
            <a:xfrm>
              <a:off x="2133720" y="3641760"/>
              <a:ext cx="6095880" cy="1099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"/>
            <p:cNvSpPr/>
            <p:nvPr/>
          </p:nvSpPr>
          <p:spPr>
            <a:xfrm>
              <a:off x="3409920" y="3519720"/>
              <a:ext cx="233280" cy="45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▽</a:t>
              </a:r>
              <a:r>
                <a:rPr b="0" lang="zh-CN" sz="15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1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429720" y="350532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72204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154120" y="3678480"/>
              <a:ext cx="464400" cy="1081800"/>
            </a:xfrm>
            <a:prstGeom prst="rect">
              <a:avLst/>
            </a:prstGeom>
            <a:noFill/>
            <a:ln w="223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11596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17428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23188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29020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34888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40648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62544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68592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974640" y="35625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485160" y="4682160"/>
              <a:ext cx="17244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6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" name=""/>
          <p:cNvGrpSpPr/>
          <p:nvPr/>
        </p:nvGrpSpPr>
        <p:grpSpPr>
          <a:xfrm>
            <a:off x="2133720" y="4952880"/>
            <a:ext cx="6248160" cy="1283760"/>
            <a:chOff x="2133720" y="4952880"/>
            <a:chExt cx="6248160" cy="1283760"/>
          </a:xfrm>
        </p:grpSpPr>
        <p:sp>
          <p:nvSpPr>
            <p:cNvPr id="89" name=""/>
            <p:cNvSpPr/>
            <p:nvPr/>
          </p:nvSpPr>
          <p:spPr>
            <a:xfrm>
              <a:off x="7450920" y="594072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0" name="" descr=""/>
            <p:cNvPicPr/>
            <p:nvPr/>
          </p:nvPicPr>
          <p:blipFill>
            <a:blip r:embed="rId5"/>
            <a:stretch/>
          </p:blipFill>
          <p:spPr>
            <a:xfrm>
              <a:off x="2133720" y="5051520"/>
              <a:ext cx="6248160" cy="1099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"/>
            <p:cNvSpPr/>
            <p:nvPr/>
          </p:nvSpPr>
          <p:spPr>
            <a:xfrm>
              <a:off x="298548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29660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35528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47588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84280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904720" y="495288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509600" y="497160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570080" y="497016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7628400" y="4971600"/>
              <a:ext cx="213480" cy="19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75960" rIns="75960" tIns="37800" bIns="37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●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7623720" y="6082200"/>
              <a:ext cx="172440" cy="154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63000" rIns="63000" tIns="31320" bIns="3132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600" spc="-1" strike="noStrike">
                  <a:solidFill>
                    <a:srgbClr val="808080"/>
                  </a:solidFill>
                  <a:latin typeface="Arial"/>
                  <a:ea typeface="宋体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01" name="" descr=""/>
          <p:cNvPicPr/>
          <p:nvPr/>
        </p:nvPicPr>
        <p:blipFill>
          <a:blip r:embed="rId6"/>
          <a:stretch/>
        </p:blipFill>
        <p:spPr>
          <a:xfrm>
            <a:off x="2133720" y="6324480"/>
            <a:ext cx="6248160" cy="60984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0" y="-569736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0" y="-183024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0" y="203832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0" y="602604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0" y="9712440"/>
            <a:ext cx="100584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623120" y="1319436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Figure.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C SYSTEM</cp:lastModifiedBy>
  <dcterms:modified xsi:type="dcterms:W3CDTF">2014-01-28T03:46:08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